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1" autoAdjust="0"/>
    <p:restoredTop sz="94660"/>
  </p:normalViewPr>
  <p:slideViewPr>
    <p:cSldViewPr snapToGrid="0">
      <p:cViewPr varScale="1">
        <p:scale>
          <a:sx n="57" d="100"/>
          <a:sy n="57" d="100"/>
        </p:scale>
        <p:origin x="102" y="12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538424-E443-4C46-A81E-E4B9AD0AA68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2AFFCF6-2A62-49EF-B968-A4066C3297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710893-C0A9-49FF-B6DE-9AE8460532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68BB4-29BC-4257-9AEE-B5AAB4BEACEB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35E543-7502-4E4D-8607-F369E784A2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4E4481-35F4-4DE1-850D-ACEFB8E8F5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1591D-BB5A-4703-8CFC-0963BBAD54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49927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F7A9F5-40EF-4C54-BAB3-25C71C8A63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DC74807-551F-4703-A24D-CBBB9198B2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E437CB-1BCD-4B96-A63C-4487605BEE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68BB4-29BC-4257-9AEE-B5AAB4BEACEB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8C0D8D-FE96-417F-BF09-AF5ABDEEAF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BB8CEB-36C9-4A63-BF11-EFB6B5DB12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1591D-BB5A-4703-8CFC-0963BBAD54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297389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D27E91C-3DCB-4693-B2AF-3306532617D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B9C9F06-26E7-4D13-8D47-F066617BC0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040DD9-7812-43FE-A20B-731360C192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68BB4-29BC-4257-9AEE-B5AAB4BEACEB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89D5FB-E82A-417A-83E4-BE274C5FB8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B09652-9BD1-4DC5-BF0B-22D300C2F2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1591D-BB5A-4703-8CFC-0963BBAD54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500695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D0A685-21DA-4574-AA30-780759FD68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D7B2AB-676B-4EAA-9906-87E9A13B5DE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452424-6970-472D-9BEE-518D7CED9C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68BB4-29BC-4257-9AEE-B5AAB4BEACEB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F27A36-B75E-4EAD-9771-F74C609032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43D384-03CB-4CB1-A655-371BE6FBD2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1591D-BB5A-4703-8CFC-0963BBAD54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189201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12F095-2E4C-4628-85E6-1AF6DADCCB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D8E531-6F89-4CDF-B46A-6E62EA8735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89CCDA-009F-4E61-A171-623590C3B8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68BB4-29BC-4257-9AEE-B5AAB4BEACEB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6685EF-392E-4AB9-B270-E747A3C327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91E53B-70A8-4FCB-B6A4-C03D2A16F7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1591D-BB5A-4703-8CFC-0963BBAD54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656953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F41ACA-A058-40E7-A7F2-8CDE91D705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4FC3C2-DA5D-464F-B7DB-580048EB514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61FC12E-31A3-4459-B7B0-F7909B1E49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22954A-9F68-404D-8940-B4A3DCEC1D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68BB4-29BC-4257-9AEE-B5AAB4BEACEB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FAF32C5-1FB8-4738-AAE9-D0A595DE98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1C269FE-4625-4017-BA17-20F32B8F03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1591D-BB5A-4703-8CFC-0963BBAD54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326080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F0A0B7-83DA-48F3-AC9D-4CF7BBE39F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D397AF2-132C-4338-B14B-65A02FD07A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B69F9E3-08C5-4ECB-BCDA-984C3018BD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BA2B6A8-328F-4F79-BF0C-A777D45F6A3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5877D51-5463-4DC8-9CB0-A80AE0B81EB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7F0A9B0-B87F-4A87-B4AB-427A96435E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68BB4-29BC-4257-9AEE-B5AAB4BEACEB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47692F8-79AD-4E2F-9222-0B4864EC3A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614FE16-587D-4D51-A49B-4C4F9B80C1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1591D-BB5A-4703-8CFC-0963BBAD54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874979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751EAD-967E-427C-8644-4FABD20621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C1BAEDF-7256-456E-8377-06A30C552B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68BB4-29BC-4257-9AEE-B5AAB4BEACEB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A56FC64-3249-4EC2-B492-6BD9C1F110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C1AAB0F-3EBB-4F2D-8064-CB74734E5E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1591D-BB5A-4703-8CFC-0963BBAD54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338441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7B48076-DE04-4D09-8F3E-2268832092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68BB4-29BC-4257-9AEE-B5AAB4BEACEB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1ABFF79-0A1B-4900-A38F-7F467E3B50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ED14C62-78C4-47FA-B03A-F9CB6C5D79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1591D-BB5A-4703-8CFC-0963BBAD54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045357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ECD76E-E339-43EE-9369-98CA5DDA0D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DDAE473-11AE-4BE8-95DE-357D46B1435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7A28638-237A-4B1B-B2A1-E784311FC1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E69E224-5937-4560-8CE5-3605FFAF26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68BB4-29BC-4257-9AEE-B5AAB4BEACEB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AC949C-D7E7-429E-8366-0EA6B60AB7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899712-786F-4AFE-97D3-6E9D7DFE55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1591D-BB5A-4703-8CFC-0963BBAD54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70990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AA4F24-5B9B-40BC-A2BD-7DEFBA2B00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BEC2044-F9B0-47D5-9739-8FCE27297CF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568562-7DAD-47A6-8B96-99AC854C0E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9B7A8B-7BA8-4E72-BCB9-7269608356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68BB4-29BC-4257-9AEE-B5AAB4BEACEB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C08A726-0DF4-4D0E-A8BD-6BBE2DB8D2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2ABAC8-02EB-4E90-A13F-49B03E90DB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1591D-BB5A-4703-8CFC-0963BBAD54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874311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2BCAC0F-86B6-4B96-B8B3-649023DDDE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04A3573-C235-40CA-9E67-014B23E884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DC2FDF-A9A4-4ABA-9BB7-8B167CC6364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E68BB4-29BC-4257-9AEE-B5AAB4BEACEB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F5B3C2-1634-48E9-B753-28E3F993B57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B71BFF-762A-477C-8D78-8FBDC7A6E5C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B1591D-BB5A-4703-8CFC-0963BBAD54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732015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>
            <a:extLst>
              <a:ext uri="{FF2B5EF4-FFF2-40B4-BE49-F238E27FC236}">
                <a16:creationId xmlns:a16="http://schemas.microsoft.com/office/drawing/2014/main" id="{5A62BC04-24F2-4F89-8647-618B6B4DFB2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14344" y="478490"/>
            <a:ext cx="2581656" cy="277368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6A1E24EE-ED04-4153-B7F4-3980FA602DF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1988" y="3429000"/>
            <a:ext cx="2581656" cy="2773680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38A08172-AE32-4842-AFAE-26F488698BA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3644" y="3429000"/>
            <a:ext cx="2581656" cy="303276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47DBD15A-D9A8-48B6-877D-AC50375B47E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4005" y="511212"/>
            <a:ext cx="2581656" cy="2773680"/>
          </a:xfrm>
          <a:prstGeom prst="rect">
            <a:avLst/>
          </a:prstGeom>
        </p:spPr>
      </p:pic>
      <p:grpSp>
        <p:nvGrpSpPr>
          <p:cNvPr id="15" name="Group 14">
            <a:extLst>
              <a:ext uri="{FF2B5EF4-FFF2-40B4-BE49-F238E27FC236}">
                <a16:creationId xmlns:a16="http://schemas.microsoft.com/office/drawing/2014/main" id="{2D4A74BA-58A8-47E6-BDCF-3BD7CD08BDC7}"/>
              </a:ext>
            </a:extLst>
          </p:cNvPr>
          <p:cNvGrpSpPr/>
          <p:nvPr/>
        </p:nvGrpSpPr>
        <p:grpSpPr>
          <a:xfrm>
            <a:off x="1649264" y="581365"/>
            <a:ext cx="4137918" cy="3076792"/>
            <a:chOff x="2877671" y="158068"/>
            <a:chExt cx="5587854" cy="3534153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D30A0F95-AA67-4CA6-995B-B9A294BB70A3}"/>
                </a:ext>
              </a:extLst>
            </p:cNvPr>
            <p:cNvSpPr txBox="1"/>
            <p:nvPr/>
          </p:nvSpPr>
          <p:spPr>
            <a:xfrm>
              <a:off x="3002134" y="3393142"/>
              <a:ext cx="14891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quid Solvent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248C1627-02D1-4FBF-82B2-31D4A3A18B5C}"/>
                </a:ext>
              </a:extLst>
            </p:cNvPr>
            <p:cNvSpPr txBox="1"/>
            <p:nvPr/>
          </p:nvSpPr>
          <p:spPr>
            <a:xfrm>
              <a:off x="2877671" y="166633"/>
              <a:ext cx="16136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lt-Blending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AA3890E-445C-4F7B-A7C3-C1C39CB087D0}"/>
                </a:ext>
              </a:extLst>
            </p:cNvPr>
            <p:cNvSpPr txBox="1"/>
            <p:nvPr/>
          </p:nvSpPr>
          <p:spPr>
            <a:xfrm>
              <a:off x="6472519" y="158068"/>
              <a:ext cx="19930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wder-Blending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E8D2F49A-F9AB-400D-BEE8-E408936F8379}"/>
                </a:ext>
              </a:extLst>
            </p:cNvPr>
            <p:cNvSpPr txBox="1"/>
            <p:nvPr/>
          </p:nvSpPr>
          <p:spPr>
            <a:xfrm>
              <a:off x="6472519" y="3415222"/>
              <a:ext cx="19930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olid Solvent</a:t>
              </a:r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E412F438-BE42-4392-B13B-6945D5ED85C9}"/>
              </a:ext>
            </a:extLst>
          </p:cNvPr>
          <p:cNvSpPr txBox="1"/>
          <p:nvPr/>
        </p:nvSpPr>
        <p:spPr>
          <a:xfrm>
            <a:off x="6974540" y="2797617"/>
            <a:ext cx="313764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Additional </a:t>
            </a:r>
            <a:r>
              <a:rPr lang="en-CA"/>
              <a:t>Figure 4: </a:t>
            </a:r>
            <a:r>
              <a:rPr lang="en-CA" dirty="0"/>
              <a:t>Analysis of degradation for each material preparation technique over time</a:t>
            </a:r>
          </a:p>
        </p:txBody>
      </p:sp>
    </p:spTree>
    <p:extLst>
      <p:ext uri="{BB962C8B-B14F-4D97-AF65-F5344CB8AC3E}">
        <p14:creationId xmlns:p14="http://schemas.microsoft.com/office/powerpoint/2010/main" val="2895695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20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anda</dc:creator>
  <cp:lastModifiedBy>Amanda</cp:lastModifiedBy>
  <cp:revision>3</cp:revision>
  <dcterms:created xsi:type="dcterms:W3CDTF">2020-11-04T21:09:28Z</dcterms:created>
  <dcterms:modified xsi:type="dcterms:W3CDTF">2021-01-21T03:10:13Z</dcterms:modified>
</cp:coreProperties>
</file>